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5" r:id="rId2"/>
    <p:sldId id="264" r:id="rId3"/>
    <p:sldId id="266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064" userDrawn="1">
          <p15:clr>
            <a:srgbClr val="A4A3A4"/>
          </p15:clr>
        </p15:guide>
        <p15:guide id="3" pos="5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setti, Marcela" initials="PM" lastIdx="1" clrIdx="0">
    <p:extLst>
      <p:ext uri="{19B8F6BF-5375-455C-9EA6-DF929625EA0E}">
        <p15:presenceInfo xmlns:p15="http://schemas.microsoft.com/office/powerpoint/2012/main" userId="S::mpasetti@som.umaryland.edu::b07389b3-2439-4cfc-bf2b-4be8006a753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37" autoAdjust="0"/>
    <p:restoredTop sz="96196" autoAdjust="0"/>
  </p:normalViewPr>
  <p:slideViewPr>
    <p:cSldViewPr snapToGrid="0">
      <p:cViewPr varScale="1">
        <p:scale>
          <a:sx n="80" d="100"/>
          <a:sy n="80" d="100"/>
        </p:scale>
        <p:origin x="2916" y="84"/>
      </p:cViewPr>
      <p:guideLst>
        <p:guide orient="horz" pos="2880"/>
        <p:guide pos="2064"/>
        <p:guide pos="5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895828-B24F-4908-94E0-30F75EE2DB01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F4356E-9C93-4F52-9F52-DDA2E4AB7F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6653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F4356E-9C93-4F52-9F52-DDA2E4AB7FE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9643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987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459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515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511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01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14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267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111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692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396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031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AC69C2-9F50-4CA1-B0A9-19A328F08CFF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2B541-4147-4540-B0DC-13EED40326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715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733D8B5-1D5B-4681-82DD-F6D6D05C77F0}"/>
              </a:ext>
            </a:extLst>
          </p:cNvPr>
          <p:cNvSpPr txBox="1"/>
          <p:nvPr/>
        </p:nvSpPr>
        <p:spPr>
          <a:xfrm>
            <a:off x="613610" y="2815389"/>
            <a:ext cx="591953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dirty="0"/>
              <a:t>Supplementary Figur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EBC0B8D-C8D0-4104-9E59-B62B34EE9D5D}"/>
              </a:ext>
            </a:extLst>
          </p:cNvPr>
          <p:cNvSpPr txBox="1"/>
          <p:nvPr/>
        </p:nvSpPr>
        <p:spPr>
          <a:xfrm>
            <a:off x="1998141" y="1725642"/>
            <a:ext cx="255691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dirty="0"/>
              <a:t>Edelman et al.</a:t>
            </a:r>
          </a:p>
        </p:txBody>
      </p:sp>
    </p:spTree>
    <p:extLst>
      <p:ext uri="{BB962C8B-B14F-4D97-AF65-F5344CB8AC3E}">
        <p14:creationId xmlns:p14="http://schemas.microsoft.com/office/powerpoint/2010/main" val="10833292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1856098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60A633-0DEE-482E-91B7-5BEE142EF151}"/>
              </a:ext>
            </a:extLst>
          </p:cNvPr>
          <p:cNvSpPr txBox="1"/>
          <p:nvPr/>
        </p:nvSpPr>
        <p:spPr>
          <a:xfrm>
            <a:off x="4078761" y="81213"/>
            <a:ext cx="2489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B7FB8C7-3E68-4F7D-BD35-2B82CFFC44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94477"/>
            <a:ext cx="6858000" cy="55438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17649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7187564_2000_05_22_CT">
            <a:extLst>
              <a:ext uri="{FF2B5EF4-FFF2-40B4-BE49-F238E27FC236}">
                <a16:creationId xmlns:a16="http://schemas.microsoft.com/office/drawing/2014/main" id="{AF91470B-CEEE-47B6-9F81-31F16DCA01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325" r="6339" b="18007"/>
          <a:stretch>
            <a:fillRect/>
          </a:stretch>
        </p:blipFill>
        <p:spPr bwMode="auto">
          <a:xfrm>
            <a:off x="600652" y="972887"/>
            <a:ext cx="5351895" cy="3731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125F082-2FCF-443D-913F-260EAE80898F}"/>
              </a:ext>
            </a:extLst>
          </p:cNvPr>
          <p:cNvSpPr txBox="1"/>
          <p:nvPr/>
        </p:nvSpPr>
        <p:spPr>
          <a:xfrm>
            <a:off x="3668707" y="35925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4033627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5</TotalTime>
  <Words>14</Words>
  <Application>Microsoft Office PowerPoint</Application>
  <PresentationFormat>On-screen Show (4:3)</PresentationFormat>
  <Paragraphs>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NIEUR protocol figures.</dc:title>
  <dc:creator>Deming, Meagan</dc:creator>
  <cp:lastModifiedBy>Sztein, Marcelo</cp:lastModifiedBy>
  <cp:revision>68</cp:revision>
  <dcterms:created xsi:type="dcterms:W3CDTF">2019-08-14T21:05:55Z</dcterms:created>
  <dcterms:modified xsi:type="dcterms:W3CDTF">2019-11-14T21:15:56Z</dcterms:modified>
</cp:coreProperties>
</file>